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306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E5AA6-4551-4593-8E92-20E1ECA973CF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074C-F73B-4883-AA85-5F0ABA71FA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224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E5AA6-4551-4593-8E92-20E1ECA973CF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074C-F73B-4883-AA85-5F0ABA71FA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391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E5AA6-4551-4593-8E92-20E1ECA973CF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074C-F73B-4883-AA85-5F0ABA71FA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159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E5AA6-4551-4593-8E92-20E1ECA973CF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074C-F73B-4883-AA85-5F0ABA71FA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069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E5AA6-4551-4593-8E92-20E1ECA973CF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074C-F73B-4883-AA85-5F0ABA71FA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318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E5AA6-4551-4593-8E92-20E1ECA973CF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074C-F73B-4883-AA85-5F0ABA71FA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627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E5AA6-4551-4593-8E92-20E1ECA973CF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074C-F73B-4883-AA85-5F0ABA71FA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229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E5AA6-4551-4593-8E92-20E1ECA973CF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074C-F73B-4883-AA85-5F0ABA71FA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247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E5AA6-4551-4593-8E92-20E1ECA973CF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074C-F73B-4883-AA85-5F0ABA71FA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0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E5AA6-4551-4593-8E92-20E1ECA973CF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074C-F73B-4883-AA85-5F0ABA71FA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245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E5AA6-4551-4593-8E92-20E1ECA973CF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074C-F73B-4883-AA85-5F0ABA71FA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385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EE5AA6-4551-4593-8E92-20E1ECA973CF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3C074C-F73B-4883-AA85-5F0ABA71FA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791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AA64D4D-D1FF-48FD-8B35-1C6320FBA7B4}"/>
              </a:ext>
            </a:extLst>
          </p:cNvPr>
          <p:cNvSpPr txBox="1"/>
          <p:nvPr/>
        </p:nvSpPr>
        <p:spPr>
          <a:xfrm>
            <a:off x="1807852" y="839999"/>
            <a:ext cx="304892" cy="2914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94" b="1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255A614-4C87-4837-9A26-C70F14C3FBB7}"/>
              </a:ext>
            </a:extLst>
          </p:cNvPr>
          <p:cNvSpPr txBox="1"/>
          <p:nvPr/>
        </p:nvSpPr>
        <p:spPr>
          <a:xfrm>
            <a:off x="3891933" y="839999"/>
            <a:ext cx="295274" cy="2914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94" b="1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pic>
        <p:nvPicPr>
          <p:cNvPr id="4" name="Picture 2" descr="F:\Running Papers\Shabnam Malik_US\CucD_MUC13\Cartoon.png">
            <a:extLst>
              <a:ext uri="{FF2B5EF4-FFF2-40B4-BE49-F238E27FC236}">
                <a16:creationId xmlns:a16="http://schemas.microsoft.com/office/drawing/2014/main" id="{B0688D2F-9577-4AA8-9AE0-86A89A5F6BE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162" t="15791" r="33355" b="3525"/>
          <a:stretch/>
        </p:blipFill>
        <p:spPr bwMode="auto">
          <a:xfrm>
            <a:off x="1832902" y="1131489"/>
            <a:ext cx="1761971" cy="25876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F:\Running Papers\Shabnam Malik_US\CucD_MUC13\Surface.png">
            <a:extLst>
              <a:ext uri="{FF2B5EF4-FFF2-40B4-BE49-F238E27FC236}">
                <a16:creationId xmlns:a16="http://schemas.microsoft.com/office/drawing/2014/main" id="{B46E0782-AE36-4E5C-B281-9C1DF3DC6A8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25" t="10664" r="30745"/>
          <a:stretch/>
        </p:blipFill>
        <p:spPr bwMode="auto">
          <a:xfrm>
            <a:off x="4133851" y="1069243"/>
            <a:ext cx="1834079" cy="25100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8E63FCD-C383-4663-86DA-988EF1735E05}"/>
              </a:ext>
            </a:extLst>
          </p:cNvPr>
          <p:cNvSpPr txBox="1"/>
          <p:nvPr/>
        </p:nvSpPr>
        <p:spPr>
          <a:xfrm>
            <a:off x="2507522" y="3427686"/>
            <a:ext cx="184731" cy="2914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IN" sz="1294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818BDDD-E670-43E9-B355-49AFB41EF1FE}"/>
              </a:ext>
            </a:extLst>
          </p:cNvPr>
          <p:cNvSpPr txBox="1"/>
          <p:nvPr/>
        </p:nvSpPr>
        <p:spPr>
          <a:xfrm>
            <a:off x="3545692" y="4412945"/>
            <a:ext cx="912622" cy="2914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94" b="1" dirty="0">
                <a:latin typeface="Times New Roman" pitchFamily="18" charset="0"/>
                <a:cs typeface="Times New Roman" pitchFamily="18" charset="0"/>
              </a:rPr>
              <a:t>Figure. S1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FC2E295-3612-4127-894E-F6C84251C4E2}"/>
              </a:ext>
            </a:extLst>
          </p:cNvPr>
          <p:cNvSpPr/>
          <p:nvPr/>
        </p:nvSpPr>
        <p:spPr>
          <a:xfrm>
            <a:off x="1371600" y="533400"/>
            <a:ext cx="4953000" cy="37338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EFAAC66-5D36-42EA-9E91-31A0CD8F14F9}"/>
              </a:ext>
            </a:extLst>
          </p:cNvPr>
          <p:cNvSpPr/>
          <p:nvPr/>
        </p:nvSpPr>
        <p:spPr>
          <a:xfrm>
            <a:off x="1084553" y="4914712"/>
            <a:ext cx="552709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: Binding orientation of Cuc D to MUC13. A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rtoon representation of Cuc D complex with MUC13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urface representation of Cuc D in complex with (B)  MUC13. 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03192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22F4A678-87D5-4017-98B2-4BA8DADA6F64}"/>
              </a:ext>
            </a:extLst>
          </p:cNvPr>
          <p:cNvGrpSpPr/>
          <p:nvPr/>
        </p:nvGrpSpPr>
        <p:grpSpPr>
          <a:xfrm>
            <a:off x="289270" y="990600"/>
            <a:ext cx="6349654" cy="5455385"/>
            <a:chOff x="172344" y="2159895"/>
            <a:chExt cx="6349654" cy="5455385"/>
          </a:xfrm>
        </p:grpSpPr>
        <p:pic>
          <p:nvPicPr>
            <p:cNvPr id="5" name="Picture 4" descr="A close up of a map&#10;&#10;Description generated with high confidence">
              <a:extLst>
                <a:ext uri="{FF2B5EF4-FFF2-40B4-BE49-F238E27FC236}">
                  <a16:creationId xmlns:a16="http://schemas.microsoft.com/office/drawing/2014/main" id="{CB327F51-F68C-4F26-8628-1502F23E09E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87061" y="4277756"/>
              <a:ext cx="2495418" cy="2495418"/>
            </a:xfrm>
            <a:prstGeom prst="rect">
              <a:avLst/>
            </a:prstGeom>
          </p:spPr>
        </p:pic>
        <p:pic>
          <p:nvPicPr>
            <p:cNvPr id="6" name="Picture 5" descr="A close up of a logo&#10;&#10;Description generated with high confidence">
              <a:extLst>
                <a:ext uri="{FF2B5EF4-FFF2-40B4-BE49-F238E27FC236}">
                  <a16:creationId xmlns:a16="http://schemas.microsoft.com/office/drawing/2014/main" id="{BF455434-C377-45DB-82A7-5649E215CE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92" r="8406"/>
            <a:stretch/>
          </p:blipFill>
          <p:spPr>
            <a:xfrm>
              <a:off x="3812424" y="2388744"/>
              <a:ext cx="2709574" cy="188901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570D5FC1-276F-4FBD-B590-4AD5113A75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222" t="1148" r="8416" b="1029"/>
            <a:stretch/>
          </p:blipFill>
          <p:spPr>
            <a:xfrm>
              <a:off x="281755" y="2545360"/>
              <a:ext cx="1829774" cy="1293844"/>
            </a:xfrm>
            <a:prstGeom prst="rect">
              <a:avLst/>
            </a:prstGeom>
          </p:spPr>
        </p:pic>
        <p:pic>
          <p:nvPicPr>
            <p:cNvPr id="8" name="Picture 7" descr="A close up of a logo&#10;&#10;Description generated with high confidence">
              <a:extLst>
                <a:ext uri="{FF2B5EF4-FFF2-40B4-BE49-F238E27FC236}">
                  <a16:creationId xmlns:a16="http://schemas.microsoft.com/office/drawing/2014/main" id="{BA889BF5-AB7F-4C62-980C-BB2413D408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93" r="10434" b="3176"/>
            <a:stretch/>
          </p:blipFill>
          <p:spPr>
            <a:xfrm>
              <a:off x="2111529" y="2592984"/>
              <a:ext cx="1728913" cy="1198597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993BC43-F204-49A7-B354-5E31ACCD1ED8}"/>
                </a:ext>
              </a:extLst>
            </p:cNvPr>
            <p:cNvSpPr txBox="1"/>
            <p:nvPr/>
          </p:nvSpPr>
          <p:spPr>
            <a:xfrm>
              <a:off x="172344" y="2205843"/>
              <a:ext cx="326449" cy="2693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0462C8C-A299-40AE-8DF3-C959B08269CD}"/>
                </a:ext>
              </a:extLst>
            </p:cNvPr>
            <p:cNvSpPr txBox="1"/>
            <p:nvPr/>
          </p:nvSpPr>
          <p:spPr>
            <a:xfrm>
              <a:off x="2111530" y="2173895"/>
              <a:ext cx="326449" cy="2693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DD4D07C-1ADF-4B40-8162-4D814A3748D8}"/>
                </a:ext>
              </a:extLst>
            </p:cNvPr>
            <p:cNvSpPr txBox="1"/>
            <p:nvPr/>
          </p:nvSpPr>
          <p:spPr>
            <a:xfrm>
              <a:off x="4156030" y="2159895"/>
              <a:ext cx="326449" cy="2693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DE2ECD8-93D7-44DB-8D98-34DDB66A5302}"/>
                </a:ext>
              </a:extLst>
            </p:cNvPr>
            <p:cNvSpPr txBox="1"/>
            <p:nvPr/>
          </p:nvSpPr>
          <p:spPr>
            <a:xfrm>
              <a:off x="1660612" y="4185983"/>
              <a:ext cx="326449" cy="2693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FB6B505-B719-49B8-8970-638EEE6D6160}"/>
                </a:ext>
              </a:extLst>
            </p:cNvPr>
            <p:cNvSpPr txBox="1"/>
            <p:nvPr/>
          </p:nvSpPr>
          <p:spPr>
            <a:xfrm>
              <a:off x="3165257" y="7323790"/>
              <a:ext cx="675185" cy="291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94" b="1" dirty="0">
                  <a:latin typeface="Times New Roman" pitchFamily="18" charset="0"/>
                  <a:cs typeface="Times New Roman" pitchFamily="18" charset="0"/>
                </a:rPr>
                <a:t>Fig. S2</a:t>
              </a:r>
            </a:p>
          </p:txBody>
        </p:sp>
      </p:grpSp>
      <p:sp>
        <p:nvSpPr>
          <p:cNvPr id="14" name="Rectangle 13">
            <a:extLst>
              <a:ext uri="{FF2B5EF4-FFF2-40B4-BE49-F238E27FC236}">
                <a16:creationId xmlns:a16="http://schemas.microsoft.com/office/drawing/2014/main" id="{53AC7ABE-5C41-4260-B708-293156C088D6}"/>
              </a:ext>
            </a:extLst>
          </p:cNvPr>
          <p:cNvSpPr/>
          <p:nvPr/>
        </p:nvSpPr>
        <p:spPr>
          <a:xfrm>
            <a:off x="336126" y="296277"/>
            <a:ext cx="6369474" cy="57997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D864ECC-88C5-4794-8053-514804028FF3}"/>
              </a:ext>
            </a:extLst>
          </p:cNvPr>
          <p:cNvSpPr/>
          <p:nvPr/>
        </p:nvSpPr>
        <p:spPr>
          <a:xfrm>
            <a:off x="336126" y="6436773"/>
            <a:ext cx="574320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2: Modeling of selected MUC13 domain structure </a:t>
            </a: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Three-dimensional structure for selected domain of MUC13 as predicted by SWISS-MODEL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ree-dimensional structure analog 2E7V in PDB library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ignment of query protein (Hot pink) with structural analog (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n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2E7V in PDB library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lidation of top score model of SWISS-MODEL by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lProbity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amachandran plot of MUC13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4559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8</TotalTime>
  <Words>119</Words>
  <Application>Microsoft Office PowerPoint</Application>
  <PresentationFormat>On-screen Show (4:3)</PresentationFormat>
  <Paragraphs>1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med Sikander</dc:creator>
  <cp:lastModifiedBy>Mohammed Sikander</cp:lastModifiedBy>
  <cp:revision>7</cp:revision>
  <dcterms:created xsi:type="dcterms:W3CDTF">2019-12-22T23:12:58Z</dcterms:created>
  <dcterms:modified xsi:type="dcterms:W3CDTF">2019-12-30T20:28:43Z</dcterms:modified>
</cp:coreProperties>
</file>